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0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260"/>
    <p:restoredTop sz="96336"/>
  </p:normalViewPr>
  <p:slideViewPr>
    <p:cSldViewPr snapToGrid="0" snapToObjects="1" showGuides="1">
      <p:cViewPr varScale="1">
        <p:scale>
          <a:sx n="129" d="100"/>
          <a:sy n="129" d="100"/>
        </p:scale>
        <p:origin x="125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A13E5A-F993-8747-8C2F-A78C56A403B4}" type="datetimeFigureOut">
              <a:rPr lang="en-US" smtClean="0"/>
              <a:t>10/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5CC1D9-4400-1F4C-943C-BE8F3A8588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47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318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188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418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652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423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111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2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423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691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74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499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97C489D-F128-D84C-9F92-56E11D4EA185}"/>
              </a:ext>
            </a:extLst>
          </p:cNvPr>
          <p:cNvSpPr txBox="1"/>
          <p:nvPr/>
        </p:nvSpPr>
        <p:spPr>
          <a:xfrm>
            <a:off x="33868" y="4941332"/>
            <a:ext cx="531336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ta presented as average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± SEM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 indicates p&lt;0.05 between young and old for an individual treatment group (YV vs. OV; YS vs. OS). ^ indicates p&lt;0.05 between vehicle and senolytics for a given age group (YV vs. YS; OV vs. OS). n=6/group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4B93307-F8DE-E542-BA84-8F32744BEE3B}"/>
              </a:ext>
            </a:extLst>
          </p:cNvPr>
          <p:cNvSpPr txBox="1"/>
          <p:nvPr/>
        </p:nvSpPr>
        <p:spPr>
          <a:xfrm>
            <a:off x="9376" y="50802"/>
            <a:ext cx="43511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: Serum SASP Profile</a:t>
            </a:r>
          </a:p>
        </p:txBody>
      </p:sp>
      <p:graphicFrame>
        <p:nvGraphicFramePr>
          <p:cNvPr id="5" name="Table 3">
            <a:extLst>
              <a:ext uri="{FF2B5EF4-FFF2-40B4-BE49-F238E27FC236}">
                <a16:creationId xmlns:a16="http://schemas.microsoft.com/office/drawing/2014/main" id="{4E260EF1-F2BB-824C-AC35-88509BDE300C}"/>
              </a:ext>
            </a:extLst>
          </p:cNvPr>
          <p:cNvGraphicFramePr>
            <a:graphicFrameLocks noGrp="1"/>
          </p:cNvGraphicFramePr>
          <p:nvPr/>
        </p:nvGraphicFramePr>
        <p:xfrm>
          <a:off x="84668" y="369332"/>
          <a:ext cx="5313361" cy="4572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82687">
                  <a:extLst>
                    <a:ext uri="{9D8B030D-6E8A-4147-A177-3AD203B41FA5}">
                      <a16:colId xmlns:a16="http://schemas.microsoft.com/office/drawing/2014/main" val="3814522062"/>
                    </a:ext>
                  </a:extLst>
                </a:gridCol>
                <a:gridCol w="906463">
                  <a:extLst>
                    <a:ext uri="{9D8B030D-6E8A-4147-A177-3AD203B41FA5}">
                      <a16:colId xmlns:a16="http://schemas.microsoft.com/office/drawing/2014/main" val="1419426879"/>
                    </a:ext>
                  </a:extLst>
                </a:gridCol>
                <a:gridCol w="1074737">
                  <a:extLst>
                    <a:ext uri="{9D8B030D-6E8A-4147-A177-3AD203B41FA5}">
                      <a16:colId xmlns:a16="http://schemas.microsoft.com/office/drawing/2014/main" val="3521612567"/>
                    </a:ext>
                  </a:extLst>
                </a:gridCol>
                <a:gridCol w="1074737">
                  <a:extLst>
                    <a:ext uri="{9D8B030D-6E8A-4147-A177-3AD203B41FA5}">
                      <a16:colId xmlns:a16="http://schemas.microsoft.com/office/drawing/2014/main" val="436547687"/>
                    </a:ext>
                  </a:extLst>
                </a:gridCol>
                <a:gridCol w="1074737">
                  <a:extLst>
                    <a:ext uri="{9D8B030D-6E8A-4147-A177-3AD203B41FA5}">
                      <a16:colId xmlns:a16="http://schemas.microsoft.com/office/drawing/2014/main" val="3285910302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V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48071911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A-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1.7 ± 69.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28.7 ± 219.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97.0 ± 478.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18.7 ± 336.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6361130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otaxi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4.7 ± 40.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4.2 ± 49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81.2 ± 45.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9.8 ± 43.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06445129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CSF/CSF-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.1 ± 12.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.3 ± 61.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7 ± 1.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.4 ± 4.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93874409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9.9 ± 14.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.4 ± 21.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.3 ± 2.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4 ± 2.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85362783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8 ± 3.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.8 ± 4.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.6 ± 18.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.6 ± 17.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15043521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2 ± 2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2 ± 1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7 ± 1.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0 ± 2.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79678776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6.0 ± 29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2.5 ± 37.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2.8 ± 23.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7.2 ± 50.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49379034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6 ± 7.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.5 ± 7.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.1 ± 16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.6 ± 11.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9827407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.2 ± 5.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.3 ± 13.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0 ± 4.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.9 ± 5.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49562526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7.6 ± 4.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.4 ± 6.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.1 ± 13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0.1 ± 13.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7767062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-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.3 ± 5.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.6 ± 9.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.2 ± 5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.3 ± 10.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81519109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9 ± 4.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8 ± 1.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2 ± 5.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3 ± 3.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89482256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P-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2.1 ± 43.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0.4 ± 16.2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^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3.4 ± 14.5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1.1 ± 15.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58453213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TES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.3 ± 6.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.7 ± 10.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7.1 ± 8.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.5 ± 7.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445754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3861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0</TotalTime>
  <Words>260</Words>
  <Application>Microsoft Macintosh PowerPoint</Application>
  <PresentationFormat>On-screen Show (4:3)</PresentationFormat>
  <Paragraphs>7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ngan, Cory M.</dc:creator>
  <cp:lastModifiedBy>Dungan, Cory M.</cp:lastModifiedBy>
  <cp:revision>62</cp:revision>
  <dcterms:created xsi:type="dcterms:W3CDTF">2021-03-08T16:18:05Z</dcterms:created>
  <dcterms:modified xsi:type="dcterms:W3CDTF">2021-10-02T22:07:44Z</dcterms:modified>
</cp:coreProperties>
</file>